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winserver16\Data\mdcrc\Research%20Server%20General\Research\NGS\NGS%20paper\Data\966%20unrelated\NGS%20consolidation%20-%20proband%20paper%20-%2096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ucleotide transition'!$E$3</c:f>
              <c:strCache>
                <c:ptCount val="1"/>
                <c:pt idx="0">
                  <c:v>No.of patients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rgbClr val="00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CD8-4F20-B864-B0503EF8117B}"/>
              </c:ext>
            </c:extLst>
          </c:dPt>
          <c:dPt>
            <c:idx val="7"/>
            <c:invertIfNegative val="0"/>
            <c:bubble3D val="0"/>
            <c:spPr>
              <a:solidFill>
                <a:srgbClr val="FF3399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CD8-4F20-B864-B0503EF8117B}"/>
              </c:ext>
            </c:extLst>
          </c:dPt>
          <c:dLbls>
            <c:dLbl>
              <c:idx val="3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1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3CD8-4F20-B864-B0503EF8117B}"/>
                </c:ext>
              </c:extLst>
            </c:dLbl>
            <c:dLbl>
              <c:idx val="7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1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3CD8-4F20-B864-B0503EF8117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Nucleotide transition'!$D$4:$D$32</c:f>
              <c:strCache>
                <c:ptCount val="29"/>
                <c:pt idx="0">
                  <c:v>A&gt;G</c:v>
                </c:pt>
                <c:pt idx="1">
                  <c:v>A&gt;C</c:v>
                </c:pt>
                <c:pt idx="2">
                  <c:v>A&gt;T</c:v>
                </c:pt>
                <c:pt idx="3">
                  <c:v>G&gt;A</c:v>
                </c:pt>
                <c:pt idx="4">
                  <c:v>G&gt;C</c:v>
                </c:pt>
                <c:pt idx="5">
                  <c:v>G&gt;T</c:v>
                </c:pt>
                <c:pt idx="6">
                  <c:v>C&gt;G</c:v>
                </c:pt>
                <c:pt idx="7">
                  <c:v>C&gt;T</c:v>
                </c:pt>
                <c:pt idx="8">
                  <c:v>T&gt;A</c:v>
                </c:pt>
                <c:pt idx="9">
                  <c:v>T&gt;G</c:v>
                </c:pt>
                <c:pt idx="10">
                  <c:v>T&gt;C</c:v>
                </c:pt>
                <c:pt idx="11">
                  <c:v>del A</c:v>
                </c:pt>
                <c:pt idx="12">
                  <c:v>del AA</c:v>
                </c:pt>
                <c:pt idx="13">
                  <c:v>del AG</c:v>
                </c:pt>
                <c:pt idx="14">
                  <c:v>del G</c:v>
                </c:pt>
                <c:pt idx="15">
                  <c:v>delGA</c:v>
                </c:pt>
                <c:pt idx="16">
                  <c:v>delC</c:v>
                </c:pt>
                <c:pt idx="17">
                  <c:v>delCA</c:v>
                </c:pt>
                <c:pt idx="18">
                  <c:v>delT</c:v>
                </c:pt>
                <c:pt idx="19">
                  <c:v>delTT</c:v>
                </c:pt>
                <c:pt idx="20">
                  <c:v>delTACA</c:v>
                </c:pt>
                <c:pt idx="21">
                  <c:v>dupA</c:v>
                </c:pt>
                <c:pt idx="22">
                  <c:v>dupAA</c:v>
                </c:pt>
                <c:pt idx="23">
                  <c:v>dupAAGT</c:v>
                </c:pt>
                <c:pt idx="24">
                  <c:v>dupG</c:v>
                </c:pt>
                <c:pt idx="25">
                  <c:v>dupT</c:v>
                </c:pt>
                <c:pt idx="26">
                  <c:v>insC</c:v>
                </c:pt>
                <c:pt idx="27">
                  <c:v>insT</c:v>
                </c:pt>
                <c:pt idx="28">
                  <c:v>indel</c:v>
                </c:pt>
              </c:strCache>
            </c:strRef>
          </c:cat>
          <c:val>
            <c:numRef>
              <c:f>'Nucleotide transition'!$E$4:$E$32</c:f>
              <c:numCache>
                <c:formatCode>General</c:formatCode>
                <c:ptCount val="29"/>
                <c:pt idx="0">
                  <c:v>2</c:v>
                </c:pt>
                <c:pt idx="1">
                  <c:v>1</c:v>
                </c:pt>
                <c:pt idx="2">
                  <c:v>4</c:v>
                </c:pt>
                <c:pt idx="3">
                  <c:v>13</c:v>
                </c:pt>
                <c:pt idx="4">
                  <c:v>7</c:v>
                </c:pt>
                <c:pt idx="5">
                  <c:v>8</c:v>
                </c:pt>
                <c:pt idx="6">
                  <c:v>3</c:v>
                </c:pt>
                <c:pt idx="7">
                  <c:v>19</c:v>
                </c:pt>
                <c:pt idx="8">
                  <c:v>1</c:v>
                </c:pt>
                <c:pt idx="9">
                  <c:v>2</c:v>
                </c:pt>
                <c:pt idx="10">
                  <c:v>1</c:v>
                </c:pt>
                <c:pt idx="11">
                  <c:v>7</c:v>
                </c:pt>
                <c:pt idx="12">
                  <c:v>1</c:v>
                </c:pt>
                <c:pt idx="13">
                  <c:v>1</c:v>
                </c:pt>
                <c:pt idx="14">
                  <c:v>3</c:v>
                </c:pt>
                <c:pt idx="15">
                  <c:v>1</c:v>
                </c:pt>
                <c:pt idx="16">
                  <c:v>2</c:v>
                </c:pt>
                <c:pt idx="17">
                  <c:v>2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3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2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CD8-4F20-B864-B0503EF811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8"/>
        <c:overlap val="-10"/>
        <c:axId val="97534336"/>
        <c:axId val="97536256"/>
      </c:barChart>
      <c:catAx>
        <c:axId val="975343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100" b="1"/>
                  <a:t>Type of Transit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7536256"/>
        <c:crosses val="autoZero"/>
        <c:auto val="1"/>
        <c:lblAlgn val="ctr"/>
        <c:lblOffset val="100"/>
        <c:noMultiLvlLbl val="0"/>
      </c:catAx>
      <c:valAx>
        <c:axId val="975362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100" b="1"/>
                  <a:t>No.of patients</a:t>
                </a:r>
              </a:p>
            </c:rich>
          </c:tx>
          <c:layout>
            <c:manualLayout>
              <c:xMode val="edge"/>
              <c:yMode val="edge"/>
              <c:x val="9.1764146201817019E-3"/>
              <c:y val="0.298087123550505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7534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4-01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13652" y="782740"/>
            <a:ext cx="86208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S3 Fig: Types of nucleotide transitions observed in 92 DMD patients analysed by NGS</a:t>
            </a:r>
            <a:endParaRPr lang="en-IN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2612230" y="1562099"/>
          <a:ext cx="6967539" cy="3733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63344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mdcrc</cp:lastModifiedBy>
  <cp:revision>6</cp:revision>
  <dcterms:created xsi:type="dcterms:W3CDTF">2020-01-14T07:41:46Z</dcterms:created>
  <dcterms:modified xsi:type="dcterms:W3CDTF">2020-01-14T07:45:37Z</dcterms:modified>
</cp:coreProperties>
</file>